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kumimoji="1"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70"/>
    <p:restoredTop sz="94637"/>
  </p:normalViewPr>
  <p:slideViewPr>
    <p:cSldViewPr snapToGrid="0" snapToObjects="1" showGuides="1">
      <p:cViewPr varScale="1">
        <p:scale>
          <a:sx n="72" d="100"/>
          <a:sy n="72" d="100"/>
        </p:scale>
        <p:origin x="2736" y="21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926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6892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467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0432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503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989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2102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0247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7861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431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4857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D2724-B8F7-244F-B2FA-8010ABCF4658}" type="datetimeFigureOut">
              <a:rPr kumimoji="1" lang="ja-JP" altLang="en-US" smtClean="0"/>
              <a:t>2020/3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DB409-E073-CE4A-98B7-A5F7BAFDEA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7070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CA4210DB-B250-8149-BBB4-FFA21BDE748D}"/>
              </a:ext>
            </a:extLst>
          </p:cNvPr>
          <p:cNvGrpSpPr/>
          <p:nvPr/>
        </p:nvGrpSpPr>
        <p:grpSpPr>
          <a:xfrm>
            <a:off x="1187564" y="1081615"/>
            <a:ext cx="4482872" cy="1587588"/>
            <a:chOff x="1139488" y="633379"/>
            <a:chExt cx="4482872" cy="1587588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29B6DA43-3297-A949-BF8C-E742BC39D6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35640" y="852967"/>
              <a:ext cx="4386720" cy="1368000"/>
            </a:xfrm>
            <a:prstGeom prst="rect">
              <a:avLst/>
            </a:prstGeom>
          </p:spPr>
        </p:pic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31D23953-17BA-0643-A36C-8856A0280344}"/>
                </a:ext>
              </a:extLst>
            </p:cNvPr>
            <p:cNvSpPr/>
            <p:nvPr/>
          </p:nvSpPr>
          <p:spPr>
            <a:xfrm>
              <a:off x="1139488" y="633379"/>
              <a:ext cx="1705916" cy="25558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llean_ghost-faced_bat</a:t>
              </a:r>
              <a:endParaRPr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EEDE7C7F-7D3E-2F4A-B053-F04DECA85929}"/>
              </a:ext>
            </a:extLst>
          </p:cNvPr>
          <p:cNvGrpSpPr/>
          <p:nvPr/>
        </p:nvGrpSpPr>
        <p:grpSpPr>
          <a:xfrm>
            <a:off x="1187564" y="2739289"/>
            <a:ext cx="4482872" cy="1601473"/>
            <a:chOff x="1139488" y="2220552"/>
            <a:chExt cx="4482872" cy="1601473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507B388D-A238-9E43-A0A5-6B5019CD87E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35640" y="2454025"/>
              <a:ext cx="4386720" cy="1368000"/>
            </a:xfrm>
            <a:prstGeom prst="rect">
              <a:avLst/>
            </a:prstGeom>
          </p:spPr>
        </p:pic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22087903-4258-2240-8BFD-D744030AD988}"/>
                </a:ext>
              </a:extLst>
            </p:cNvPr>
            <p:cNvSpPr/>
            <p:nvPr/>
          </p:nvSpPr>
          <p:spPr>
            <a:xfrm>
              <a:off x="1139488" y="2220552"/>
              <a:ext cx="1412566" cy="25558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eat_roundleaf_bat</a:t>
              </a:r>
              <a:endParaRPr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3E39210F-401A-DD43-8D99-D43A12D73EF4}"/>
              </a:ext>
            </a:extLst>
          </p:cNvPr>
          <p:cNvGrpSpPr/>
          <p:nvPr/>
        </p:nvGrpSpPr>
        <p:grpSpPr>
          <a:xfrm>
            <a:off x="1187564" y="4410848"/>
            <a:ext cx="4453802" cy="1586717"/>
            <a:chOff x="1139488" y="3946094"/>
            <a:chExt cx="4453802" cy="1586717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1E68A2B5-8626-F741-9FD2-0B16F9C7622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35640" y="4164811"/>
              <a:ext cx="4357650" cy="1368000"/>
            </a:xfrm>
            <a:prstGeom prst="rect">
              <a:avLst/>
            </a:prstGeom>
          </p:spPr>
        </p:pic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CA37793A-4331-DE4E-894F-D51FC4FBE722}"/>
                </a:ext>
              </a:extLst>
            </p:cNvPr>
            <p:cNvSpPr/>
            <p:nvPr/>
          </p:nvSpPr>
          <p:spPr>
            <a:xfrm>
              <a:off x="1139488" y="3946094"/>
              <a:ext cx="1406154" cy="25558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eater_bulldog_bat</a:t>
              </a:r>
              <a:endParaRPr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C9DD0298-CE82-D540-90F5-1F384B33C2F2}"/>
              </a:ext>
            </a:extLst>
          </p:cNvPr>
          <p:cNvGrpSpPr/>
          <p:nvPr/>
        </p:nvGrpSpPr>
        <p:grpSpPr>
          <a:xfrm>
            <a:off x="1187564" y="6067651"/>
            <a:ext cx="4482872" cy="1582329"/>
            <a:chOff x="1139488" y="5661268"/>
            <a:chExt cx="4482872" cy="1582329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818A4F29-69E5-0248-AC01-EB0289C983A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35640" y="5875597"/>
              <a:ext cx="4386720" cy="1368000"/>
            </a:xfrm>
            <a:prstGeom prst="rect">
              <a:avLst/>
            </a:prstGeom>
          </p:spPr>
        </p:pic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91AFC3CF-D231-4344-A0F7-D15C284C4F73}"/>
                </a:ext>
              </a:extLst>
            </p:cNvPr>
            <p:cNvSpPr/>
            <p:nvPr/>
          </p:nvSpPr>
          <p:spPr>
            <a:xfrm>
              <a:off x="1139488" y="5661268"/>
              <a:ext cx="1784463" cy="25558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eater_false_vampire_bat</a:t>
              </a:r>
              <a:endParaRPr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A744108C-1D05-1148-916D-7454A267958A}"/>
              </a:ext>
            </a:extLst>
          </p:cNvPr>
          <p:cNvGrpSpPr/>
          <p:nvPr/>
        </p:nvGrpSpPr>
        <p:grpSpPr>
          <a:xfrm>
            <a:off x="1187564" y="7720067"/>
            <a:ext cx="4482872" cy="1565588"/>
            <a:chOff x="1139488" y="7388794"/>
            <a:chExt cx="4482872" cy="1565588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BA2CC82F-B261-E442-AFFE-393A42D8C45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235640" y="7586382"/>
              <a:ext cx="4386720" cy="1368000"/>
            </a:xfrm>
            <a:prstGeom prst="rect">
              <a:avLst/>
            </a:prstGeom>
          </p:spPr>
        </p:pic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2038C96C-2ECE-534E-8446-923B68B20B6E}"/>
                </a:ext>
              </a:extLst>
            </p:cNvPr>
            <p:cNvSpPr/>
            <p:nvPr/>
          </p:nvSpPr>
          <p:spPr>
            <a:xfrm>
              <a:off x="1139488" y="7388794"/>
              <a:ext cx="1649811" cy="25558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nell's_mustached_bat</a:t>
              </a:r>
              <a:endParaRPr lang="ja-JP" altLang="en-US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63951980-F627-2B4A-A270-9D2411A5AFB2}"/>
              </a:ext>
            </a:extLst>
          </p:cNvPr>
          <p:cNvSpPr/>
          <p:nvPr/>
        </p:nvSpPr>
        <p:spPr>
          <a:xfrm>
            <a:off x="742763" y="493233"/>
            <a:ext cx="595214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sz="1200" b="1" dirty="0"/>
              <a:t>Table S9. </a:t>
            </a:r>
            <a:r>
              <a:rPr lang="en" altLang="ja-JP" sz="1200" dirty="0"/>
              <a:t>Results of selection analyses based on the branch-site model in several bat species with high </a:t>
            </a:r>
            <a:r>
              <a:rPr lang="en" altLang="ja-JP" sz="1200" dirty="0">
                <a:latin typeface="Symbol" pitchFamily="2" charset="2"/>
              </a:rPr>
              <a:t>w</a:t>
            </a:r>
            <a:r>
              <a:rPr lang="ja-JP" altLang="en-US" sz="1200"/>
              <a:t> </a:t>
            </a:r>
            <a:r>
              <a:rPr lang="en-US" altLang="ja-JP" sz="1200" dirty="0"/>
              <a:t>values without frameshift or premature stop codon mutations in Fig. 3I.</a:t>
            </a:r>
            <a:endParaRPr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2038391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59</Words>
  <Application>Microsoft Macintosh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6</cp:revision>
  <dcterms:created xsi:type="dcterms:W3CDTF">2020-01-10T08:45:24Z</dcterms:created>
  <dcterms:modified xsi:type="dcterms:W3CDTF">2020-03-19T12:09:51Z</dcterms:modified>
</cp:coreProperties>
</file>